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40860-34FB-4A96-A8F5-C65886D731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D6FDD-FCE5-44E7-9B4F-22A4A7AB34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E26B9-9F42-4341-8770-4B5004410F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77567-131E-4BAA-945B-9D069BD132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C406F0-DE50-4A77-A97B-102E9428E4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20F8A-C87D-4983-A71D-C9FC910815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D8FF15-AC50-4446-AD98-F86E509435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3320A-7474-45B3-B6C5-DB492EEC93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679F5B-72E8-4AF5-BD35-01FA5E1529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6D9D0-E971-4786-9B8F-2046B9BC8F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BB1D0-A99A-4CB5-9713-852B9190A5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92A57-A2EA-4AA4-A7EC-644B76247D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B58C77-6CB0-4E79-9E1E-1EE61A3BEE35}" type="datetime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C5D33C-D2ED-44FB-A7D1-8C5D19650069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9"/>
          <p:cNvSpPr/>
          <p:nvPr/>
        </p:nvSpPr>
        <p:spPr>
          <a:xfrm>
            <a:off x="549360" y="380880"/>
            <a:ext cx="575928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2: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ison of the clinical variables of the breast cancer patients in the TMA versus those with ANXA1 scores for the BCAC and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CA1|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tion carriers patient serie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2"/>
          <p:cNvGraphicFramePr/>
          <p:nvPr/>
        </p:nvGraphicFramePr>
        <p:xfrm>
          <a:off x="622440" y="1116000"/>
          <a:ext cx="5686200" cy="74296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22440" y="1116000"/>
                    <a:ext cx="5686200" cy="7429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19"/>
          <p:cNvSpPr/>
          <p:nvPr/>
        </p:nvSpPr>
        <p:spPr>
          <a:xfrm>
            <a:off x="509760" y="1501920"/>
            <a:ext cx="576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. table 2: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inuation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Object 1"/>
          <p:cNvGraphicFramePr/>
          <p:nvPr/>
        </p:nvGraphicFramePr>
        <p:xfrm>
          <a:off x="593640" y="2195640"/>
          <a:ext cx="5686560" cy="63338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6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93640" y="2195640"/>
                    <a:ext cx="5686560" cy="633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11:57:37Z</dcterms:created>
  <dc:creator>Marcelo Sobral Leite</dc:creator>
  <dc:description/>
  <dc:language>en-US</dc:language>
  <cp:lastModifiedBy>Marcelo Sobral-Leite</cp:lastModifiedBy>
  <cp:lastPrinted>2014-09-08T08:30:29Z</cp:lastPrinted>
  <dcterms:modified xsi:type="dcterms:W3CDTF">2015-04-29T15:18:27Z</dcterms:modified>
  <cp:revision>413</cp:revision>
  <dc:subject/>
  <dc:title>Slide 1</dc:title>
</cp:coreProperties>
</file>